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91335E-F0DD-44F0-B375-59A26DF9779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490D92-F15E-4B70-BEDC-E845BBA22FE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E55CB9-4EB0-4538-9CF8-5911941D5E9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C566E2-FF9D-4C1A-9E3E-D6B7713B86A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BF585D-9165-46CD-AD3F-EEB935FAD5B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C57914-6B46-4055-B384-D72293F008F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70E720-B117-4240-813B-B3CC7893B5C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DC094D-AA96-4878-B7BE-7A12423CFD9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67DAA1-58B4-482E-8C01-1181B70899D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AAEF98-5ADA-4020-ACDE-D61849ECC3E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AD7D2A-46CA-44A7-9A98-66A8E73615D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F54EFC-3214-4064-9043-C010BA52A68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8D4A137-40FE-461A-A24C-FD8873445610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Grafico 2" descr=""/>
          <p:cNvPicPr/>
          <p:nvPr/>
        </p:nvPicPr>
        <p:blipFill>
          <a:blip r:embed="rId1"/>
          <a:stretch/>
        </p:blipFill>
        <p:spPr>
          <a:xfrm>
            <a:off x="2273400" y="536400"/>
            <a:ext cx="2097000" cy="1737000"/>
          </a:xfrm>
          <a:prstGeom prst="rect">
            <a:avLst/>
          </a:prstGeom>
          <a:ln w="0">
            <a:noFill/>
          </a:ln>
        </p:spPr>
      </p:pic>
      <p:sp>
        <p:nvSpPr>
          <p:cNvPr id="42" name="CasellaDiTesto 11"/>
          <p:cNvSpPr/>
          <p:nvPr/>
        </p:nvSpPr>
        <p:spPr>
          <a:xfrm>
            <a:off x="2637000" y="395280"/>
            <a:ext cx="244764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Calibri"/>
              </a:rPr>
              <a:t>Non cirrhotic HCCs N=1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 Box 21"/>
          <p:cNvSpPr/>
          <p:nvPr/>
        </p:nvSpPr>
        <p:spPr>
          <a:xfrm>
            <a:off x="2421000" y="2124000"/>
            <a:ext cx="2879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BV  (5)          HCV  (5)           -/- (2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 Box 14"/>
          <p:cNvSpPr/>
          <p:nvPr/>
        </p:nvSpPr>
        <p:spPr>
          <a:xfrm rot="16200000">
            <a:off x="1578600" y="1138320"/>
            <a:ext cx="1003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verage 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CasellaDiTesto 7"/>
          <p:cNvSpPr/>
          <p:nvPr/>
        </p:nvSpPr>
        <p:spPr>
          <a:xfrm>
            <a:off x="2124000" y="582480"/>
            <a:ext cx="432000" cy="165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.4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.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8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6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4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46" name=""/>
          <p:cNvGraphicFramePr/>
          <p:nvPr/>
        </p:nvGraphicFramePr>
        <p:xfrm>
          <a:off x="2565360" y="3219480"/>
          <a:ext cx="1655640" cy="3513240"/>
        </p:xfrm>
        <a:graphic>
          <a:graphicData uri="http://schemas.openxmlformats.org/drawingml/2006/table">
            <a:tbl>
              <a:tblPr/>
              <a:tblGrid>
                <a:gridCol w="868320"/>
                <a:gridCol w="787320"/>
              </a:tblGrid>
              <a:tr h="319680">
                <a:tc gridSpan="2"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ll the cases with HCV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7352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A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(RQ</a:t>
                      </a:r>
                      <a:r>
                        <a:rPr b="1" lang="en-US" sz="1000" spc="-1" strike="noStrike" baseline="-25000">
                          <a:solidFill>
                            <a:srgbClr val="000000"/>
                          </a:solidFill>
                          <a:latin typeface="Calibri"/>
                        </a:rPr>
                        <a:t>HCC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/RQ</a:t>
                      </a:r>
                      <a:r>
                        <a:rPr b="1" lang="en-US" sz="1000" spc="-1" strike="noStrike" baseline="-25000">
                          <a:solidFill>
                            <a:srgbClr val="000000"/>
                          </a:solidFill>
                          <a:latin typeface="Calibri"/>
                        </a:rPr>
                        <a:t>PT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984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9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3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020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2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9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984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8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5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020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3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984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3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5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984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7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164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7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1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020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7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1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984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8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5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984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8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.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020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4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2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984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0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984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3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.8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020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4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3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984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8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020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ean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60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984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E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1458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492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-Test for single group mea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=0.01677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7" name="Rettangolo 7"/>
          <p:cNvSpPr/>
          <p:nvPr/>
        </p:nvSpPr>
        <p:spPr>
          <a:xfrm>
            <a:off x="1268280" y="6875640"/>
            <a:ext cx="4464360" cy="76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Book Antiqua"/>
              </a:rPr>
              <a:t>The miR-193a is down-modulated in the HCC patients with and without cirrhosis subdivided on the basis of the HCV virus infection (n=15). The mean R value was 0.604±0,14 which was significantly different from the expected value=1, p=0.0167.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CasellaDiTesto 9"/>
          <p:cNvSpPr/>
          <p:nvPr/>
        </p:nvSpPr>
        <p:spPr>
          <a:xfrm>
            <a:off x="1700280" y="2411280"/>
            <a:ext cx="3384360" cy="596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Book Antiqua"/>
              </a:rPr>
              <a:t>Stratification of the non-cirrhotic HCCs on the basis of the type of hepatitis virus infection. HBV (n=5); HCV (n=5); HBV/HCV (n=0); -/- (n=2).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CasellaDiTesto 24"/>
          <p:cNvSpPr/>
          <p:nvPr/>
        </p:nvSpPr>
        <p:spPr>
          <a:xfrm>
            <a:off x="5157720" y="8686800"/>
            <a:ext cx="1943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Book Antiqua"/>
              </a:rPr>
              <a:t>Additional file 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CasellaDiTesto 10"/>
          <p:cNvSpPr/>
          <p:nvPr/>
        </p:nvSpPr>
        <p:spPr>
          <a:xfrm>
            <a:off x="2498760" y="689040"/>
            <a:ext cx="719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82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CasellaDiTesto 11"/>
          <p:cNvSpPr/>
          <p:nvPr/>
        </p:nvSpPr>
        <p:spPr>
          <a:xfrm>
            <a:off x="3692520" y="1116000"/>
            <a:ext cx="720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55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CasellaDiTesto 12"/>
          <p:cNvSpPr/>
          <p:nvPr/>
        </p:nvSpPr>
        <p:spPr>
          <a:xfrm>
            <a:off x="3078000" y="708120"/>
            <a:ext cx="720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81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7-05T12:40:38Z</dcterms:created>
  <dc:creator>salvi</dc:creator>
  <dc:description/>
  <dc:language>en-US</dc:language>
  <cp:lastModifiedBy>De Petro</cp:lastModifiedBy>
  <dcterms:modified xsi:type="dcterms:W3CDTF">2013-07-05T15:42:55Z</dcterms:modified>
  <cp:revision>2</cp:revision>
  <dc:subject/>
  <dc:title>Diapositiva 1</dc:title>
</cp:coreProperties>
</file>